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E46C8-1F3C-4CBB-8156-23846DAE0C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A8E38-B552-41C3-AE27-809081A953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4AE01-3FC7-4DC0-84C7-895465C951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83C45-F057-4923-8C6C-C3C39E6CA3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611DB-CF4E-4AFF-ABE8-C5648E4E57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95E6E-B232-4D10-9893-58F4146E84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43AA75-6300-480D-AAF0-8E2A0B4066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78F7A-C314-44BE-85C8-9BA9689C4D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714F6-9D13-4010-B526-7CB459B0B3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031ED-08C4-4721-B092-D69B8E3BCB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6D27A-EE8B-4AA1-B24A-73FAE136C1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91801-B864-4242-AB2D-FB7D134E66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2FB630-8C93-491A-A950-CFEB7B8DC3F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6"/>
          <p:cNvGraphicFramePr/>
          <p:nvPr/>
        </p:nvGraphicFramePr>
        <p:xfrm>
          <a:off x="1428840" y="4038480"/>
          <a:ext cx="4133880" cy="1900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28840" y="4038480"/>
                    <a:ext cx="4133880" cy="1900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457200" y="6248520"/>
          <a:ext cx="6095880" cy="2814480"/>
        </p:xfrm>
        <a:graphic>
          <a:graphicData uri="http://schemas.openxmlformats.org/drawingml/2006/table">
            <a:tbl>
              <a:tblPr/>
              <a:tblGrid>
                <a:gridCol w="1189080"/>
                <a:gridCol w="461880"/>
                <a:gridCol w="461880"/>
                <a:gridCol w="574920"/>
                <a:gridCol w="463320"/>
                <a:gridCol w="462240"/>
                <a:gridCol w="463320"/>
                <a:gridCol w="460440"/>
                <a:gridCol w="534960"/>
                <a:gridCol w="511200"/>
                <a:gridCol w="512640"/>
              </a:tblGrid>
              <a:tr h="19656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cto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gridSpan="10">
                  <a:txBody>
                    <a:bodyPr lIns="90000" rIns="90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ference gen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44800">
                <a:tc>
                  <a:txBody>
                    <a:bodyPr lIns="90000" rIns="900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F1α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S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-BOX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2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PR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B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BI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N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K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P2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ank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o Mean [CP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7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9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0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7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0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.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7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3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8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.6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r Mean [CP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7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9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0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7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0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.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7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4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8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.6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 [CP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1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5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.0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9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7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4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5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.6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.4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.1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x [CP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.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.5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.0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.7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4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0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.0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.3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.4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.2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d dev [± CP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88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V [% CP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0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n [x-fold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4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3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0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6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2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6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2.3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6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3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1.3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x [x-fold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0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3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.5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a-DK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d dev [± x-fold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7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6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4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2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eff. of corr. [r]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79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0.05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0.27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-valu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7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8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87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8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矩形 1"/>
          <p:cNvSpPr/>
          <p:nvPr/>
        </p:nvSpPr>
        <p:spPr>
          <a:xfrm>
            <a:off x="889920" y="2286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矩形 6"/>
          <p:cNvSpPr/>
          <p:nvPr/>
        </p:nvSpPr>
        <p:spPr>
          <a:xfrm>
            <a:off x="889560" y="213372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矩形 7"/>
          <p:cNvSpPr/>
          <p:nvPr/>
        </p:nvSpPr>
        <p:spPr>
          <a:xfrm>
            <a:off x="889920" y="40384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矩形 8"/>
          <p:cNvSpPr/>
          <p:nvPr/>
        </p:nvSpPr>
        <p:spPr>
          <a:xfrm>
            <a:off x="889920" y="59054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矩形 13"/>
          <p:cNvSpPr/>
          <p:nvPr/>
        </p:nvSpPr>
        <p:spPr>
          <a:xfrm>
            <a:off x="3048120" y="5819760"/>
            <a:ext cx="1218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ast stable   Most stable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" name="直接箭头连接符 2"/>
          <p:cNvCxnSpPr/>
          <p:nvPr/>
        </p:nvCxnSpPr>
        <p:spPr>
          <a:xfrm>
            <a:off x="4190760" y="5919480"/>
            <a:ext cx="5338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0" name="直接箭头连接符 18"/>
          <p:cNvCxnSpPr/>
          <p:nvPr/>
        </p:nvCxnSpPr>
        <p:spPr>
          <a:xfrm flipH="1">
            <a:off x="2559960" y="5917680"/>
            <a:ext cx="5324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1" name="矩形 6"/>
          <p:cNvSpPr/>
          <p:nvPr/>
        </p:nvSpPr>
        <p:spPr>
          <a:xfrm rot="16200000">
            <a:off x="824040" y="3055680"/>
            <a:ext cx="1189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irwise variations (V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矩形 6"/>
          <p:cNvSpPr/>
          <p:nvPr/>
        </p:nvSpPr>
        <p:spPr>
          <a:xfrm rot="16200000">
            <a:off x="1011600" y="4862160"/>
            <a:ext cx="81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ability valu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1387440" y="0"/>
          <a:ext cx="4191120" cy="22176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387440" y="0"/>
                    <a:ext cx="4191120" cy="2217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"/>
          <p:cNvGraphicFramePr/>
          <p:nvPr/>
        </p:nvGraphicFramePr>
        <p:xfrm>
          <a:off x="1295280" y="2057400"/>
          <a:ext cx="4286520" cy="212868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5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295280" y="2057400"/>
                    <a:ext cx="4286520" cy="2128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张永亮</dc:creator>
  <dc:description/>
  <dc:language>en-US</dc:language>
  <cp:lastModifiedBy>微软用户</cp:lastModifiedBy>
  <dcterms:modified xsi:type="dcterms:W3CDTF">2012-08-14T04:19:40Z</dcterms:modified>
  <cp:revision>2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